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8193" autoAdjust="0"/>
    <p:restoredTop sz="96391" autoAdjust="0"/>
  </p:normalViewPr>
  <p:slideViewPr>
    <p:cSldViewPr snapToGrid="0">
      <p:cViewPr>
        <p:scale>
          <a:sx n="27" d="100"/>
          <a:sy n="27" d="100"/>
        </p:scale>
        <p:origin x="2648" y="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DA9F6-4235-448A-8393-5021E3447AC7}" type="datetimeFigureOut">
              <a:rPr lang="ko-KR" altLang="en-US" smtClean="0"/>
              <a:t>2021-04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B0E84-96B6-4356-8F86-CDDB2EA1659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0004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DA9F6-4235-448A-8393-5021E3447AC7}" type="datetimeFigureOut">
              <a:rPr lang="ko-KR" altLang="en-US" smtClean="0"/>
              <a:t>2021-04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B0E84-96B6-4356-8F86-CDDB2EA1659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385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DA9F6-4235-448A-8393-5021E3447AC7}" type="datetimeFigureOut">
              <a:rPr lang="ko-KR" altLang="en-US" smtClean="0"/>
              <a:t>2021-04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B0E84-96B6-4356-8F86-CDDB2EA1659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73090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DA9F6-4235-448A-8393-5021E3447AC7}" type="datetimeFigureOut">
              <a:rPr lang="ko-KR" altLang="en-US" smtClean="0"/>
              <a:t>2021-04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B0E84-96B6-4356-8F86-CDDB2EA1659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9418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DA9F6-4235-448A-8393-5021E3447AC7}" type="datetimeFigureOut">
              <a:rPr lang="ko-KR" altLang="en-US" smtClean="0"/>
              <a:t>2021-04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B0E84-96B6-4356-8F86-CDDB2EA1659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666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DA9F6-4235-448A-8393-5021E3447AC7}" type="datetimeFigureOut">
              <a:rPr lang="ko-KR" altLang="en-US" smtClean="0"/>
              <a:t>2021-04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B0E84-96B6-4356-8F86-CDDB2EA1659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670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DA9F6-4235-448A-8393-5021E3447AC7}" type="datetimeFigureOut">
              <a:rPr lang="ko-KR" altLang="en-US" smtClean="0"/>
              <a:t>2021-04-2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B0E84-96B6-4356-8F86-CDDB2EA1659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689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DA9F6-4235-448A-8393-5021E3447AC7}" type="datetimeFigureOut">
              <a:rPr lang="ko-KR" altLang="en-US" smtClean="0"/>
              <a:t>2021-04-2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B0E84-96B6-4356-8F86-CDDB2EA1659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2975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DA9F6-4235-448A-8393-5021E3447AC7}" type="datetimeFigureOut">
              <a:rPr lang="ko-KR" altLang="en-US" smtClean="0"/>
              <a:t>2021-04-2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B0E84-96B6-4356-8F86-CDDB2EA1659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2159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DA9F6-4235-448A-8393-5021E3447AC7}" type="datetimeFigureOut">
              <a:rPr lang="ko-KR" altLang="en-US" smtClean="0"/>
              <a:t>2021-04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B0E84-96B6-4356-8F86-CDDB2EA1659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0684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DA9F6-4235-448A-8393-5021E3447AC7}" type="datetimeFigureOut">
              <a:rPr lang="ko-KR" altLang="en-US" smtClean="0"/>
              <a:t>2021-04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B0E84-96B6-4356-8F86-CDDB2EA1659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6514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2DA9F6-4235-448A-8393-5021E3447AC7}" type="datetimeFigureOut">
              <a:rPr lang="ko-KR" altLang="en-US" smtClean="0"/>
              <a:t>2021-04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B0E84-96B6-4356-8F86-CDDB2EA1659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5768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1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1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직사각형 44"/>
          <p:cNvSpPr/>
          <p:nvPr/>
        </p:nvSpPr>
        <p:spPr>
          <a:xfrm>
            <a:off x="566064" y="1917033"/>
            <a:ext cx="11146971" cy="7184572"/>
          </a:xfrm>
          <a:prstGeom prst="rect">
            <a:avLst/>
          </a:prstGeom>
          <a:solidFill>
            <a:schemeClr val="accent1"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" name="TextBox 3"/>
          <p:cNvSpPr txBox="1"/>
          <p:nvPr/>
        </p:nvSpPr>
        <p:spPr>
          <a:xfrm>
            <a:off x="566063" y="13802161"/>
            <a:ext cx="1114697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ko-KR" alt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Flow chart of participants.</a:t>
            </a:r>
          </a:p>
        </p:txBody>
      </p:sp>
      <p:sp>
        <p:nvSpPr>
          <p:cNvPr id="5" name="직사각형 4"/>
          <p:cNvSpPr/>
          <p:nvPr/>
        </p:nvSpPr>
        <p:spPr>
          <a:xfrm>
            <a:off x="2140576" y="2872070"/>
            <a:ext cx="5733735" cy="690880"/>
          </a:xfrm>
          <a:prstGeom prst="rect">
            <a:avLst/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 kg/m</a:t>
            </a:r>
            <a:r>
              <a:rPr lang="en-US" altLang="ko-KR" sz="20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≤ body mass index (BMI) &lt; 30 kg/m</a:t>
            </a:r>
            <a:r>
              <a:rPr lang="en-US" altLang="ko-KR" sz="20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 algn="ctr"/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100 subjects</a:t>
            </a:r>
            <a:endParaRPr lang="ko-KR" altLang="en-US" sz="2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1316713" y="4728458"/>
            <a:ext cx="2942313" cy="690880"/>
          </a:xfrm>
          <a:prstGeom prst="rect">
            <a:avLst/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 group</a:t>
            </a:r>
          </a:p>
          <a:p>
            <a:pPr algn="ctr"/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20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50)</a:t>
            </a:r>
            <a:endParaRPr lang="ko-KR" altLang="en-US" sz="2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5793419" y="4728458"/>
            <a:ext cx="2942313" cy="690880"/>
          </a:xfrm>
          <a:prstGeom prst="rect">
            <a:avLst/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CD group</a:t>
            </a:r>
          </a:p>
          <a:p>
            <a:pPr algn="ctr"/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20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50)</a:t>
            </a:r>
            <a:endParaRPr lang="ko-KR" altLang="en-US" sz="2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1316713" y="8087056"/>
            <a:ext cx="2942313" cy="690880"/>
          </a:xfrm>
          <a:prstGeom prst="rect">
            <a:avLst/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 group</a:t>
            </a:r>
          </a:p>
          <a:p>
            <a:pPr algn="ctr"/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20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50)</a:t>
            </a:r>
            <a:endParaRPr lang="ko-KR" altLang="en-US" sz="2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5793419" y="8087056"/>
            <a:ext cx="2942313" cy="690880"/>
          </a:xfrm>
          <a:prstGeom prst="rect">
            <a:avLst/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CD group</a:t>
            </a:r>
          </a:p>
          <a:p>
            <a:pPr algn="ctr"/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20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47)</a:t>
            </a:r>
            <a:endParaRPr lang="ko-KR" altLang="en-US" sz="2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직선 화살표 연결선 10"/>
          <p:cNvCxnSpPr>
            <a:endCxn id="6" idx="0"/>
          </p:cNvCxnSpPr>
          <p:nvPr/>
        </p:nvCxnSpPr>
        <p:spPr>
          <a:xfrm flipH="1">
            <a:off x="2787870" y="3562950"/>
            <a:ext cx="1471157" cy="1165508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화살표 연결선 11"/>
          <p:cNvCxnSpPr/>
          <p:nvPr/>
        </p:nvCxnSpPr>
        <p:spPr>
          <a:xfrm>
            <a:off x="5734876" y="3562950"/>
            <a:ext cx="1529700" cy="1165508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화살표 연결선 14"/>
          <p:cNvCxnSpPr>
            <a:stCxn id="7" idx="2"/>
            <a:endCxn id="9" idx="0"/>
          </p:cNvCxnSpPr>
          <p:nvPr/>
        </p:nvCxnSpPr>
        <p:spPr>
          <a:xfrm>
            <a:off x="7264576" y="5419338"/>
            <a:ext cx="0" cy="2667718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3503065" y="4100049"/>
            <a:ext cx="2965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uterized Randomization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345721" y="5983712"/>
            <a:ext cx="45049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participants dropped out voluntarily</a:t>
            </a:r>
          </a:p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e participant denied the CT measurement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직사각형 38"/>
          <p:cNvSpPr/>
          <p:nvPr/>
        </p:nvSpPr>
        <p:spPr>
          <a:xfrm>
            <a:off x="1316712" y="11547717"/>
            <a:ext cx="2942313" cy="1089493"/>
          </a:xfrm>
          <a:prstGeom prst="rect">
            <a:avLst/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Metabolic status maintenance group</a:t>
            </a:r>
            <a:r>
              <a:rPr lang="ko-KR" altLang="ko-KR" sz="2000" b="1" dirty="0">
                <a:effectLst/>
              </a:rPr>
              <a:t> </a:t>
            </a:r>
            <a:endParaRPr lang="en-US" altLang="ko-KR" sz="2000" b="1" dirty="0">
              <a:effectLst/>
            </a:endParaRPr>
          </a:p>
          <a:p>
            <a:pPr algn="ctr"/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20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17, controls)</a:t>
            </a:r>
            <a:endParaRPr lang="ko-KR" altLang="en-US" sz="2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직사각형 39"/>
          <p:cNvSpPr/>
          <p:nvPr/>
        </p:nvSpPr>
        <p:spPr>
          <a:xfrm>
            <a:off x="5793418" y="11547718"/>
            <a:ext cx="2942313" cy="1089492"/>
          </a:xfrm>
          <a:prstGeom prst="rect">
            <a:avLst/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Metabolic status improvement group</a:t>
            </a:r>
            <a:r>
              <a:rPr lang="en-US" altLang="ko-KR" sz="20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endParaRPr lang="en-US" altLang="ko-KR" sz="2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20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12, tests)</a:t>
            </a:r>
            <a:endParaRPr lang="ko-KR" altLang="en-US" sz="2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직사각형 46"/>
          <p:cNvSpPr/>
          <p:nvPr/>
        </p:nvSpPr>
        <p:spPr>
          <a:xfrm>
            <a:off x="6263200" y="1960921"/>
            <a:ext cx="544983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dirty="0">
                <a:latin typeface="Times New Roman" panose="02020603050405020304" pitchFamily="18" charset="0"/>
                <a:ea typeface="궁서체" panose="02030609000101010101" pitchFamily="17" charset="-127"/>
                <a:cs typeface="Times New Roman" panose="02020603050405020304" pitchFamily="18" charset="0"/>
              </a:rPr>
              <a:t>The basic framework of the present study was based on a previous study (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inicalTrials.gov; NCT03135132</a:t>
            </a:r>
            <a:r>
              <a:rPr lang="en-US" altLang="ko-KR" dirty="0">
                <a:latin typeface="Times New Roman" panose="02020603050405020304" pitchFamily="18" charset="0"/>
                <a:ea typeface="궁서체" panose="02030609000101010101" pitchFamily="17" charset="-127"/>
                <a:cs typeface="Times New Roman" panose="02020603050405020304" pitchFamily="18" charset="0"/>
              </a:rPr>
              <a:t>)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직선 화살표 연결선 47"/>
          <p:cNvCxnSpPr/>
          <p:nvPr/>
        </p:nvCxnSpPr>
        <p:spPr>
          <a:xfrm>
            <a:off x="2787868" y="5419338"/>
            <a:ext cx="0" cy="2667718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직사각형 48"/>
          <p:cNvSpPr/>
          <p:nvPr/>
        </p:nvSpPr>
        <p:spPr>
          <a:xfrm>
            <a:off x="7359074" y="6892102"/>
            <a:ext cx="373771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ea typeface="궁서체" panose="02030609000101010101" pitchFamily="17" charset="-127"/>
              </a:rPr>
              <a:t>A 300 kcal/day reduction in their usual caloric intakes</a:t>
            </a:r>
            <a:endParaRPr lang="ko-KR" altLang="en-US" dirty="0"/>
          </a:p>
        </p:txBody>
      </p:sp>
      <p:sp>
        <p:nvSpPr>
          <p:cNvPr id="50" name="직사각형 49"/>
          <p:cNvSpPr/>
          <p:nvPr/>
        </p:nvSpPr>
        <p:spPr>
          <a:xfrm>
            <a:off x="703669" y="6611415"/>
            <a:ext cx="20441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dirty="0">
                <a:latin typeface="Times New Roman" panose="02020603050405020304" pitchFamily="18" charset="0"/>
                <a:ea typeface="궁서체" panose="02030609000101010101" pitchFamily="17" charset="-127"/>
              </a:rPr>
              <a:t>Usual dietary intake</a:t>
            </a:r>
            <a:endParaRPr lang="ko-KR" altLang="en-US" dirty="0"/>
          </a:p>
        </p:txBody>
      </p:sp>
      <p:sp>
        <p:nvSpPr>
          <p:cNvPr id="25" name="직사각형 24"/>
          <p:cNvSpPr/>
          <p:nvPr/>
        </p:nvSpPr>
        <p:spPr>
          <a:xfrm>
            <a:off x="3935521" y="6624166"/>
            <a:ext cx="21531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dirty="0">
                <a:latin typeface="Times New Roman" panose="02020603050405020304" pitchFamily="18" charset="0"/>
                <a:ea typeface="궁서체" panose="02030609000101010101" pitchFamily="17" charset="-127"/>
              </a:rPr>
              <a:t>12-week intervention</a:t>
            </a:r>
            <a:endParaRPr lang="ko-KR" altLang="en-US" dirty="0"/>
          </a:p>
        </p:txBody>
      </p:sp>
      <p:cxnSp>
        <p:nvCxnSpPr>
          <p:cNvPr id="31" name="직선 화살표 연결선 30">
            <a:extLst>
              <a:ext uri="{FF2B5EF4-FFF2-40B4-BE49-F238E27FC236}">
                <a16:creationId xmlns:a16="http://schemas.microsoft.com/office/drawing/2014/main" id="{880A3642-9EC8-48BA-AD56-17F0B59E6670}"/>
              </a:ext>
            </a:extLst>
          </p:cNvPr>
          <p:cNvCxnSpPr/>
          <p:nvPr/>
        </p:nvCxnSpPr>
        <p:spPr>
          <a:xfrm>
            <a:off x="2787868" y="8777936"/>
            <a:ext cx="0" cy="2667718"/>
          </a:xfrm>
          <a:prstGeom prst="straightConnector1">
            <a:avLst/>
          </a:prstGeom>
          <a:ln w="25400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화살표 연결선 31">
            <a:extLst>
              <a:ext uri="{FF2B5EF4-FFF2-40B4-BE49-F238E27FC236}">
                <a16:creationId xmlns:a16="http://schemas.microsoft.com/office/drawing/2014/main" id="{89E8A8B8-9B1D-4B74-B903-0B1C619C509C}"/>
              </a:ext>
            </a:extLst>
          </p:cNvPr>
          <p:cNvCxnSpPr/>
          <p:nvPr/>
        </p:nvCxnSpPr>
        <p:spPr>
          <a:xfrm>
            <a:off x="7283665" y="8787461"/>
            <a:ext cx="0" cy="2667718"/>
          </a:xfrm>
          <a:prstGeom prst="straightConnector1">
            <a:avLst/>
          </a:prstGeom>
          <a:ln w="25400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75356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</TotalTime>
  <Words>127</Words>
  <Application>Microsoft Office PowerPoint</Application>
  <PresentationFormat>사용자 지정</PresentationFormat>
  <Paragraphs>2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 Minjoo</dc:creator>
  <cp:lastModifiedBy>한 영민</cp:lastModifiedBy>
  <cp:revision>13</cp:revision>
  <dcterms:created xsi:type="dcterms:W3CDTF">2019-09-02T01:26:42Z</dcterms:created>
  <dcterms:modified xsi:type="dcterms:W3CDTF">2021-04-22T11:27:05Z</dcterms:modified>
</cp:coreProperties>
</file>